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0" r:id="rId2"/>
    <p:sldId id="278" r:id="rId3"/>
    <p:sldId id="264" r:id="rId4"/>
    <p:sldId id="265" r:id="rId5"/>
  </p:sldIdLst>
  <p:sldSz cx="8640763" cy="104394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288" userDrawn="1">
          <p15:clr>
            <a:srgbClr val="A4A3A4"/>
          </p15:clr>
        </p15:guide>
        <p15:guide id="2" pos="272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700710"/>
    <a:srgbClr val="872E25"/>
    <a:srgbClr val="E824BE"/>
    <a:srgbClr val="5B0101"/>
    <a:srgbClr val="830201"/>
    <a:srgbClr val="630101"/>
    <a:srgbClr val="67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3824" autoAdjust="0"/>
    <p:restoredTop sz="94660"/>
  </p:normalViewPr>
  <p:slideViewPr>
    <p:cSldViewPr>
      <p:cViewPr varScale="1">
        <p:scale>
          <a:sx n="44" d="100"/>
          <a:sy n="44" d="100"/>
        </p:scale>
        <p:origin x="1676" y="44"/>
      </p:cViewPr>
      <p:guideLst>
        <p:guide orient="horz" pos="3288"/>
        <p:guide pos="2722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48057" y="3242981"/>
            <a:ext cx="7344649" cy="223770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96115" y="5915660"/>
            <a:ext cx="6048534" cy="2667847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959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391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0878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78379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47974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17569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87164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56759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264553" y="418061"/>
            <a:ext cx="1944172" cy="8907321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32038" y="418061"/>
            <a:ext cx="5688502" cy="890732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561" y="6708282"/>
            <a:ext cx="7344649" cy="2073381"/>
          </a:xfrm>
        </p:spPr>
        <p:txBody>
          <a:bodyPr anchor="t"/>
          <a:lstStyle>
            <a:lvl1pPr algn="l">
              <a:defRPr sz="6089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561" y="4424664"/>
            <a:ext cx="7344649" cy="2283618"/>
          </a:xfrm>
        </p:spPr>
        <p:txBody>
          <a:bodyPr anchor="b"/>
          <a:lstStyle>
            <a:lvl1pPr marL="0" indent="0">
              <a:buNone/>
              <a:defRPr sz="3044">
                <a:solidFill>
                  <a:schemeClr val="tx1">
                    <a:tint val="75000"/>
                  </a:schemeClr>
                </a:solidFill>
              </a:defRPr>
            </a:lvl1pPr>
            <a:lvl2pPr marL="695950" indent="0">
              <a:buNone/>
              <a:defRPr sz="2740">
                <a:solidFill>
                  <a:schemeClr val="tx1">
                    <a:tint val="75000"/>
                  </a:schemeClr>
                </a:solidFill>
              </a:defRPr>
            </a:lvl2pPr>
            <a:lvl3pPr marL="1391900" indent="0">
              <a:buNone/>
              <a:defRPr sz="2436">
                <a:solidFill>
                  <a:schemeClr val="tx1">
                    <a:tint val="75000"/>
                  </a:schemeClr>
                </a:solidFill>
              </a:defRPr>
            </a:lvl3pPr>
            <a:lvl4pPr marL="2087850" indent="0">
              <a:buNone/>
              <a:defRPr sz="2131">
                <a:solidFill>
                  <a:schemeClr val="tx1">
                    <a:tint val="75000"/>
                  </a:schemeClr>
                </a:solidFill>
              </a:defRPr>
            </a:lvl4pPr>
            <a:lvl5pPr marL="2783799" indent="0">
              <a:buNone/>
              <a:defRPr sz="2131">
                <a:solidFill>
                  <a:schemeClr val="tx1">
                    <a:tint val="75000"/>
                  </a:schemeClr>
                </a:solidFill>
              </a:defRPr>
            </a:lvl5pPr>
            <a:lvl6pPr marL="3479749" indent="0">
              <a:buNone/>
              <a:defRPr sz="2131">
                <a:solidFill>
                  <a:schemeClr val="tx1">
                    <a:tint val="75000"/>
                  </a:schemeClr>
                </a:solidFill>
              </a:defRPr>
            </a:lvl6pPr>
            <a:lvl7pPr marL="4175699" indent="0">
              <a:buNone/>
              <a:defRPr sz="2131">
                <a:solidFill>
                  <a:schemeClr val="tx1">
                    <a:tint val="75000"/>
                  </a:schemeClr>
                </a:solidFill>
              </a:defRPr>
            </a:lvl7pPr>
            <a:lvl8pPr marL="4871649" indent="0">
              <a:buNone/>
              <a:defRPr sz="2131">
                <a:solidFill>
                  <a:schemeClr val="tx1">
                    <a:tint val="75000"/>
                  </a:schemeClr>
                </a:solidFill>
              </a:defRPr>
            </a:lvl8pPr>
            <a:lvl9pPr marL="5567599" indent="0">
              <a:buNone/>
              <a:defRPr sz="213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32038" y="2435861"/>
            <a:ext cx="3816337" cy="6889521"/>
          </a:xfrm>
        </p:spPr>
        <p:txBody>
          <a:bodyPr/>
          <a:lstStyle>
            <a:lvl1pPr>
              <a:defRPr sz="4262"/>
            </a:lvl1pPr>
            <a:lvl2pPr>
              <a:defRPr sz="3653"/>
            </a:lvl2pPr>
            <a:lvl3pPr>
              <a:defRPr sz="3044"/>
            </a:lvl3pPr>
            <a:lvl4pPr>
              <a:defRPr sz="2740"/>
            </a:lvl4pPr>
            <a:lvl5pPr>
              <a:defRPr sz="2740"/>
            </a:lvl5pPr>
            <a:lvl6pPr>
              <a:defRPr sz="2740"/>
            </a:lvl6pPr>
            <a:lvl7pPr>
              <a:defRPr sz="2740"/>
            </a:lvl7pPr>
            <a:lvl8pPr>
              <a:defRPr sz="2740"/>
            </a:lvl8pPr>
            <a:lvl9pPr>
              <a:defRPr sz="274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92388" y="2435861"/>
            <a:ext cx="3816337" cy="6889521"/>
          </a:xfrm>
        </p:spPr>
        <p:txBody>
          <a:bodyPr/>
          <a:lstStyle>
            <a:lvl1pPr>
              <a:defRPr sz="4262"/>
            </a:lvl1pPr>
            <a:lvl2pPr>
              <a:defRPr sz="3653"/>
            </a:lvl2pPr>
            <a:lvl3pPr>
              <a:defRPr sz="3044"/>
            </a:lvl3pPr>
            <a:lvl4pPr>
              <a:defRPr sz="2740"/>
            </a:lvl4pPr>
            <a:lvl5pPr>
              <a:defRPr sz="2740"/>
            </a:lvl5pPr>
            <a:lvl6pPr>
              <a:defRPr sz="2740"/>
            </a:lvl6pPr>
            <a:lvl7pPr>
              <a:defRPr sz="2740"/>
            </a:lvl7pPr>
            <a:lvl8pPr>
              <a:defRPr sz="2740"/>
            </a:lvl8pPr>
            <a:lvl9pPr>
              <a:defRPr sz="274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2038" y="2336783"/>
            <a:ext cx="3817838" cy="973860"/>
          </a:xfrm>
        </p:spPr>
        <p:txBody>
          <a:bodyPr anchor="b"/>
          <a:lstStyle>
            <a:lvl1pPr marL="0" indent="0">
              <a:buNone/>
              <a:defRPr sz="3653" b="1"/>
            </a:lvl1pPr>
            <a:lvl2pPr marL="695950" indent="0">
              <a:buNone/>
              <a:defRPr sz="3044" b="1"/>
            </a:lvl2pPr>
            <a:lvl3pPr marL="1391900" indent="0">
              <a:buNone/>
              <a:defRPr sz="2740" b="1"/>
            </a:lvl3pPr>
            <a:lvl4pPr marL="2087850" indent="0">
              <a:buNone/>
              <a:defRPr sz="2436" b="1"/>
            </a:lvl4pPr>
            <a:lvl5pPr marL="2783799" indent="0">
              <a:buNone/>
              <a:defRPr sz="2436" b="1"/>
            </a:lvl5pPr>
            <a:lvl6pPr marL="3479749" indent="0">
              <a:buNone/>
              <a:defRPr sz="2436" b="1"/>
            </a:lvl6pPr>
            <a:lvl7pPr marL="4175699" indent="0">
              <a:buNone/>
              <a:defRPr sz="2436" b="1"/>
            </a:lvl7pPr>
            <a:lvl8pPr marL="4871649" indent="0">
              <a:buNone/>
              <a:defRPr sz="2436" b="1"/>
            </a:lvl8pPr>
            <a:lvl9pPr marL="5567599" indent="0">
              <a:buNone/>
              <a:defRPr sz="243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2038" y="3310643"/>
            <a:ext cx="3817838" cy="6014738"/>
          </a:xfrm>
        </p:spPr>
        <p:txBody>
          <a:bodyPr/>
          <a:lstStyle>
            <a:lvl1pPr>
              <a:defRPr sz="3653"/>
            </a:lvl1pPr>
            <a:lvl2pPr>
              <a:defRPr sz="3044"/>
            </a:lvl2pPr>
            <a:lvl3pPr>
              <a:defRPr sz="2740"/>
            </a:lvl3pPr>
            <a:lvl4pPr>
              <a:defRPr sz="2436"/>
            </a:lvl4pPr>
            <a:lvl5pPr>
              <a:defRPr sz="2436"/>
            </a:lvl5pPr>
            <a:lvl6pPr>
              <a:defRPr sz="2436"/>
            </a:lvl6pPr>
            <a:lvl7pPr>
              <a:defRPr sz="2436"/>
            </a:lvl7pPr>
            <a:lvl8pPr>
              <a:defRPr sz="2436"/>
            </a:lvl8pPr>
            <a:lvl9pPr>
              <a:defRPr sz="243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389388" y="2336783"/>
            <a:ext cx="3819337" cy="973860"/>
          </a:xfrm>
        </p:spPr>
        <p:txBody>
          <a:bodyPr anchor="b"/>
          <a:lstStyle>
            <a:lvl1pPr marL="0" indent="0">
              <a:buNone/>
              <a:defRPr sz="3653" b="1"/>
            </a:lvl1pPr>
            <a:lvl2pPr marL="695950" indent="0">
              <a:buNone/>
              <a:defRPr sz="3044" b="1"/>
            </a:lvl2pPr>
            <a:lvl3pPr marL="1391900" indent="0">
              <a:buNone/>
              <a:defRPr sz="2740" b="1"/>
            </a:lvl3pPr>
            <a:lvl4pPr marL="2087850" indent="0">
              <a:buNone/>
              <a:defRPr sz="2436" b="1"/>
            </a:lvl4pPr>
            <a:lvl5pPr marL="2783799" indent="0">
              <a:buNone/>
              <a:defRPr sz="2436" b="1"/>
            </a:lvl5pPr>
            <a:lvl6pPr marL="3479749" indent="0">
              <a:buNone/>
              <a:defRPr sz="2436" b="1"/>
            </a:lvl6pPr>
            <a:lvl7pPr marL="4175699" indent="0">
              <a:buNone/>
              <a:defRPr sz="2436" b="1"/>
            </a:lvl7pPr>
            <a:lvl8pPr marL="4871649" indent="0">
              <a:buNone/>
              <a:defRPr sz="2436" b="1"/>
            </a:lvl8pPr>
            <a:lvl9pPr marL="5567599" indent="0">
              <a:buNone/>
              <a:defRPr sz="243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389388" y="3310643"/>
            <a:ext cx="3819337" cy="6014738"/>
          </a:xfrm>
        </p:spPr>
        <p:txBody>
          <a:bodyPr/>
          <a:lstStyle>
            <a:lvl1pPr>
              <a:defRPr sz="3653"/>
            </a:lvl1pPr>
            <a:lvl2pPr>
              <a:defRPr sz="3044"/>
            </a:lvl2pPr>
            <a:lvl3pPr>
              <a:defRPr sz="2740"/>
            </a:lvl3pPr>
            <a:lvl4pPr>
              <a:defRPr sz="2436"/>
            </a:lvl4pPr>
            <a:lvl5pPr>
              <a:defRPr sz="2436"/>
            </a:lvl5pPr>
            <a:lvl6pPr>
              <a:defRPr sz="2436"/>
            </a:lvl6pPr>
            <a:lvl7pPr>
              <a:defRPr sz="2436"/>
            </a:lvl7pPr>
            <a:lvl8pPr>
              <a:defRPr sz="2436"/>
            </a:lvl8pPr>
            <a:lvl9pPr>
              <a:defRPr sz="243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8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8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8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2039" y="415643"/>
            <a:ext cx="2842751" cy="1768898"/>
          </a:xfrm>
        </p:spPr>
        <p:txBody>
          <a:bodyPr anchor="b"/>
          <a:lstStyle>
            <a:lvl1pPr algn="l">
              <a:defRPr sz="3044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78298" y="415643"/>
            <a:ext cx="4830427" cy="8909739"/>
          </a:xfrm>
        </p:spPr>
        <p:txBody>
          <a:bodyPr/>
          <a:lstStyle>
            <a:lvl1pPr>
              <a:defRPr sz="4871"/>
            </a:lvl1pPr>
            <a:lvl2pPr>
              <a:defRPr sz="4262"/>
            </a:lvl2pPr>
            <a:lvl3pPr>
              <a:defRPr sz="3653"/>
            </a:lvl3pPr>
            <a:lvl4pPr>
              <a:defRPr sz="3044"/>
            </a:lvl4pPr>
            <a:lvl5pPr>
              <a:defRPr sz="3044"/>
            </a:lvl5pPr>
            <a:lvl6pPr>
              <a:defRPr sz="3044"/>
            </a:lvl6pPr>
            <a:lvl7pPr>
              <a:defRPr sz="3044"/>
            </a:lvl7pPr>
            <a:lvl8pPr>
              <a:defRPr sz="3044"/>
            </a:lvl8pPr>
            <a:lvl9pPr>
              <a:defRPr sz="3044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2039" y="2184542"/>
            <a:ext cx="2842751" cy="7140840"/>
          </a:xfrm>
        </p:spPr>
        <p:txBody>
          <a:bodyPr/>
          <a:lstStyle>
            <a:lvl1pPr marL="0" indent="0">
              <a:buNone/>
              <a:defRPr sz="2131"/>
            </a:lvl1pPr>
            <a:lvl2pPr marL="695950" indent="0">
              <a:buNone/>
              <a:defRPr sz="1827"/>
            </a:lvl2pPr>
            <a:lvl3pPr marL="1391900" indent="0">
              <a:buNone/>
              <a:defRPr sz="1522"/>
            </a:lvl3pPr>
            <a:lvl4pPr marL="2087850" indent="0">
              <a:buNone/>
              <a:defRPr sz="1370"/>
            </a:lvl4pPr>
            <a:lvl5pPr marL="2783799" indent="0">
              <a:buNone/>
              <a:defRPr sz="1370"/>
            </a:lvl5pPr>
            <a:lvl6pPr marL="3479749" indent="0">
              <a:buNone/>
              <a:defRPr sz="1370"/>
            </a:lvl6pPr>
            <a:lvl7pPr marL="4175699" indent="0">
              <a:buNone/>
              <a:defRPr sz="1370"/>
            </a:lvl7pPr>
            <a:lvl8pPr marL="4871649" indent="0">
              <a:buNone/>
              <a:defRPr sz="1370"/>
            </a:lvl8pPr>
            <a:lvl9pPr marL="5567599" indent="0">
              <a:buNone/>
              <a:defRPr sz="137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93650" y="7307580"/>
            <a:ext cx="5184458" cy="862701"/>
          </a:xfrm>
        </p:spPr>
        <p:txBody>
          <a:bodyPr anchor="b"/>
          <a:lstStyle>
            <a:lvl1pPr algn="l">
              <a:defRPr sz="3044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693650" y="932780"/>
            <a:ext cx="5184458" cy="6263640"/>
          </a:xfrm>
        </p:spPr>
        <p:txBody>
          <a:bodyPr/>
          <a:lstStyle>
            <a:lvl1pPr marL="0" indent="0">
              <a:buNone/>
              <a:defRPr sz="4871"/>
            </a:lvl1pPr>
            <a:lvl2pPr marL="695950" indent="0">
              <a:buNone/>
              <a:defRPr sz="4262"/>
            </a:lvl2pPr>
            <a:lvl3pPr marL="1391900" indent="0">
              <a:buNone/>
              <a:defRPr sz="3653"/>
            </a:lvl3pPr>
            <a:lvl4pPr marL="2087850" indent="0">
              <a:buNone/>
              <a:defRPr sz="3044"/>
            </a:lvl4pPr>
            <a:lvl5pPr marL="2783799" indent="0">
              <a:buNone/>
              <a:defRPr sz="3044"/>
            </a:lvl5pPr>
            <a:lvl6pPr marL="3479749" indent="0">
              <a:buNone/>
              <a:defRPr sz="3044"/>
            </a:lvl6pPr>
            <a:lvl7pPr marL="4175699" indent="0">
              <a:buNone/>
              <a:defRPr sz="3044"/>
            </a:lvl7pPr>
            <a:lvl8pPr marL="4871649" indent="0">
              <a:buNone/>
              <a:defRPr sz="3044"/>
            </a:lvl8pPr>
            <a:lvl9pPr marL="5567599" indent="0">
              <a:buNone/>
              <a:defRPr sz="3044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693650" y="8170281"/>
            <a:ext cx="5184458" cy="1225179"/>
          </a:xfrm>
        </p:spPr>
        <p:txBody>
          <a:bodyPr/>
          <a:lstStyle>
            <a:lvl1pPr marL="0" indent="0">
              <a:buNone/>
              <a:defRPr sz="2131"/>
            </a:lvl1pPr>
            <a:lvl2pPr marL="695950" indent="0">
              <a:buNone/>
              <a:defRPr sz="1827"/>
            </a:lvl2pPr>
            <a:lvl3pPr marL="1391900" indent="0">
              <a:buNone/>
              <a:defRPr sz="1522"/>
            </a:lvl3pPr>
            <a:lvl4pPr marL="2087850" indent="0">
              <a:buNone/>
              <a:defRPr sz="1370"/>
            </a:lvl4pPr>
            <a:lvl5pPr marL="2783799" indent="0">
              <a:buNone/>
              <a:defRPr sz="1370"/>
            </a:lvl5pPr>
            <a:lvl6pPr marL="3479749" indent="0">
              <a:buNone/>
              <a:defRPr sz="1370"/>
            </a:lvl6pPr>
            <a:lvl7pPr marL="4175699" indent="0">
              <a:buNone/>
              <a:defRPr sz="1370"/>
            </a:lvl7pPr>
            <a:lvl8pPr marL="4871649" indent="0">
              <a:buNone/>
              <a:defRPr sz="1370"/>
            </a:lvl8pPr>
            <a:lvl9pPr marL="5567599" indent="0">
              <a:buNone/>
              <a:defRPr sz="137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32038" y="418060"/>
            <a:ext cx="7776687" cy="17399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2038" y="2435861"/>
            <a:ext cx="7776687" cy="688952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32038" y="9675778"/>
            <a:ext cx="2016178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82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1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52261" y="9675778"/>
            <a:ext cx="2736242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82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192547" y="9675778"/>
            <a:ext cx="2016178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82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391900" rtl="0" eaLnBrk="1" latinLnBrk="0" hangingPunct="1">
        <a:spcBef>
          <a:spcPct val="0"/>
        </a:spcBef>
        <a:buNone/>
        <a:defRPr sz="669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21962" indent="-521962" algn="l" defTabSz="1391900" rtl="0" eaLnBrk="1" latinLnBrk="0" hangingPunct="1">
        <a:spcBef>
          <a:spcPct val="20000"/>
        </a:spcBef>
        <a:buFont typeface="Arial" pitchFamily="34" charset="0"/>
        <a:buChar char="•"/>
        <a:defRPr sz="4871" kern="1200">
          <a:solidFill>
            <a:schemeClr val="tx1"/>
          </a:solidFill>
          <a:latin typeface="+mn-lt"/>
          <a:ea typeface="+mn-ea"/>
          <a:cs typeface="+mn-cs"/>
        </a:defRPr>
      </a:lvl1pPr>
      <a:lvl2pPr marL="1130918" indent="-434969" algn="l" defTabSz="1391900" rtl="0" eaLnBrk="1" latinLnBrk="0" hangingPunct="1">
        <a:spcBef>
          <a:spcPct val="20000"/>
        </a:spcBef>
        <a:buFont typeface="Arial" pitchFamily="34" charset="0"/>
        <a:buChar char="–"/>
        <a:defRPr sz="4262" kern="1200">
          <a:solidFill>
            <a:schemeClr val="tx1"/>
          </a:solidFill>
          <a:latin typeface="+mn-lt"/>
          <a:ea typeface="+mn-ea"/>
          <a:cs typeface="+mn-cs"/>
        </a:defRPr>
      </a:lvl2pPr>
      <a:lvl3pPr marL="1739875" indent="-347975" algn="l" defTabSz="1391900" rtl="0" eaLnBrk="1" latinLnBrk="0" hangingPunct="1">
        <a:spcBef>
          <a:spcPct val="20000"/>
        </a:spcBef>
        <a:buFont typeface="Arial" pitchFamily="34" charset="0"/>
        <a:buChar char="•"/>
        <a:defRPr sz="3653" kern="1200">
          <a:solidFill>
            <a:schemeClr val="tx1"/>
          </a:solidFill>
          <a:latin typeface="+mn-lt"/>
          <a:ea typeface="+mn-ea"/>
          <a:cs typeface="+mn-cs"/>
        </a:defRPr>
      </a:lvl3pPr>
      <a:lvl4pPr marL="2435824" indent="-347975" algn="l" defTabSz="1391900" rtl="0" eaLnBrk="1" latinLnBrk="0" hangingPunct="1">
        <a:spcBef>
          <a:spcPct val="20000"/>
        </a:spcBef>
        <a:buFont typeface="Arial" pitchFamily="34" charset="0"/>
        <a:buChar char="–"/>
        <a:defRPr sz="3044" kern="1200">
          <a:solidFill>
            <a:schemeClr val="tx1"/>
          </a:solidFill>
          <a:latin typeface="+mn-lt"/>
          <a:ea typeface="+mn-ea"/>
          <a:cs typeface="+mn-cs"/>
        </a:defRPr>
      </a:lvl4pPr>
      <a:lvl5pPr marL="3131774" indent="-347975" algn="l" defTabSz="1391900" rtl="0" eaLnBrk="1" latinLnBrk="0" hangingPunct="1">
        <a:spcBef>
          <a:spcPct val="20000"/>
        </a:spcBef>
        <a:buFont typeface="Arial" pitchFamily="34" charset="0"/>
        <a:buChar char="»"/>
        <a:defRPr sz="3044" kern="1200">
          <a:solidFill>
            <a:schemeClr val="tx1"/>
          </a:solidFill>
          <a:latin typeface="+mn-lt"/>
          <a:ea typeface="+mn-ea"/>
          <a:cs typeface="+mn-cs"/>
        </a:defRPr>
      </a:lvl5pPr>
      <a:lvl6pPr marL="3827724" indent="-347975" algn="l" defTabSz="1391900" rtl="0" eaLnBrk="1" latinLnBrk="0" hangingPunct="1">
        <a:spcBef>
          <a:spcPct val="20000"/>
        </a:spcBef>
        <a:buFont typeface="Arial" pitchFamily="34" charset="0"/>
        <a:buChar char="•"/>
        <a:defRPr sz="3044" kern="1200">
          <a:solidFill>
            <a:schemeClr val="tx1"/>
          </a:solidFill>
          <a:latin typeface="+mn-lt"/>
          <a:ea typeface="+mn-ea"/>
          <a:cs typeface="+mn-cs"/>
        </a:defRPr>
      </a:lvl6pPr>
      <a:lvl7pPr marL="4523674" indent="-347975" algn="l" defTabSz="1391900" rtl="0" eaLnBrk="1" latinLnBrk="0" hangingPunct="1">
        <a:spcBef>
          <a:spcPct val="20000"/>
        </a:spcBef>
        <a:buFont typeface="Arial" pitchFamily="34" charset="0"/>
        <a:buChar char="•"/>
        <a:defRPr sz="3044" kern="1200">
          <a:solidFill>
            <a:schemeClr val="tx1"/>
          </a:solidFill>
          <a:latin typeface="+mn-lt"/>
          <a:ea typeface="+mn-ea"/>
          <a:cs typeface="+mn-cs"/>
        </a:defRPr>
      </a:lvl7pPr>
      <a:lvl8pPr marL="5219624" indent="-347975" algn="l" defTabSz="1391900" rtl="0" eaLnBrk="1" latinLnBrk="0" hangingPunct="1">
        <a:spcBef>
          <a:spcPct val="20000"/>
        </a:spcBef>
        <a:buFont typeface="Arial" pitchFamily="34" charset="0"/>
        <a:buChar char="•"/>
        <a:defRPr sz="3044" kern="1200">
          <a:solidFill>
            <a:schemeClr val="tx1"/>
          </a:solidFill>
          <a:latin typeface="+mn-lt"/>
          <a:ea typeface="+mn-ea"/>
          <a:cs typeface="+mn-cs"/>
        </a:defRPr>
      </a:lvl8pPr>
      <a:lvl9pPr marL="5915574" indent="-347975" algn="l" defTabSz="1391900" rtl="0" eaLnBrk="1" latinLnBrk="0" hangingPunct="1">
        <a:spcBef>
          <a:spcPct val="20000"/>
        </a:spcBef>
        <a:buFont typeface="Arial" pitchFamily="34" charset="0"/>
        <a:buChar char="•"/>
        <a:defRPr sz="304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91900" rtl="0" eaLnBrk="1" latinLnBrk="0" hangingPunct="1">
        <a:defRPr sz="2740" kern="1200">
          <a:solidFill>
            <a:schemeClr val="tx1"/>
          </a:solidFill>
          <a:latin typeface="+mn-lt"/>
          <a:ea typeface="+mn-ea"/>
          <a:cs typeface="+mn-cs"/>
        </a:defRPr>
      </a:lvl1pPr>
      <a:lvl2pPr marL="695950" algn="l" defTabSz="1391900" rtl="0" eaLnBrk="1" latinLnBrk="0" hangingPunct="1">
        <a:defRPr sz="2740" kern="1200">
          <a:solidFill>
            <a:schemeClr val="tx1"/>
          </a:solidFill>
          <a:latin typeface="+mn-lt"/>
          <a:ea typeface="+mn-ea"/>
          <a:cs typeface="+mn-cs"/>
        </a:defRPr>
      </a:lvl2pPr>
      <a:lvl3pPr marL="1391900" algn="l" defTabSz="1391900" rtl="0" eaLnBrk="1" latinLnBrk="0" hangingPunct="1">
        <a:defRPr sz="2740" kern="1200">
          <a:solidFill>
            <a:schemeClr val="tx1"/>
          </a:solidFill>
          <a:latin typeface="+mn-lt"/>
          <a:ea typeface="+mn-ea"/>
          <a:cs typeface="+mn-cs"/>
        </a:defRPr>
      </a:lvl3pPr>
      <a:lvl4pPr marL="2087850" algn="l" defTabSz="1391900" rtl="0" eaLnBrk="1" latinLnBrk="0" hangingPunct="1">
        <a:defRPr sz="2740" kern="1200">
          <a:solidFill>
            <a:schemeClr val="tx1"/>
          </a:solidFill>
          <a:latin typeface="+mn-lt"/>
          <a:ea typeface="+mn-ea"/>
          <a:cs typeface="+mn-cs"/>
        </a:defRPr>
      </a:lvl4pPr>
      <a:lvl5pPr marL="2783799" algn="l" defTabSz="1391900" rtl="0" eaLnBrk="1" latinLnBrk="0" hangingPunct="1">
        <a:defRPr sz="2740" kern="1200">
          <a:solidFill>
            <a:schemeClr val="tx1"/>
          </a:solidFill>
          <a:latin typeface="+mn-lt"/>
          <a:ea typeface="+mn-ea"/>
          <a:cs typeface="+mn-cs"/>
        </a:defRPr>
      </a:lvl5pPr>
      <a:lvl6pPr marL="3479749" algn="l" defTabSz="1391900" rtl="0" eaLnBrk="1" latinLnBrk="0" hangingPunct="1">
        <a:defRPr sz="2740" kern="1200">
          <a:solidFill>
            <a:schemeClr val="tx1"/>
          </a:solidFill>
          <a:latin typeface="+mn-lt"/>
          <a:ea typeface="+mn-ea"/>
          <a:cs typeface="+mn-cs"/>
        </a:defRPr>
      </a:lvl6pPr>
      <a:lvl7pPr marL="4175699" algn="l" defTabSz="1391900" rtl="0" eaLnBrk="1" latinLnBrk="0" hangingPunct="1">
        <a:defRPr sz="2740" kern="1200">
          <a:solidFill>
            <a:schemeClr val="tx1"/>
          </a:solidFill>
          <a:latin typeface="+mn-lt"/>
          <a:ea typeface="+mn-ea"/>
          <a:cs typeface="+mn-cs"/>
        </a:defRPr>
      </a:lvl7pPr>
      <a:lvl8pPr marL="4871649" algn="l" defTabSz="1391900" rtl="0" eaLnBrk="1" latinLnBrk="0" hangingPunct="1">
        <a:defRPr sz="2740" kern="1200">
          <a:solidFill>
            <a:schemeClr val="tx1"/>
          </a:solidFill>
          <a:latin typeface="+mn-lt"/>
          <a:ea typeface="+mn-ea"/>
          <a:cs typeface="+mn-cs"/>
        </a:defRPr>
      </a:lvl8pPr>
      <a:lvl9pPr marL="5567599" algn="l" defTabSz="1391900" rtl="0" eaLnBrk="1" latinLnBrk="0" hangingPunct="1">
        <a:defRPr sz="27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127DB3FD-7428-404E-8DA0-D62781CCE6A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81608" y="241058"/>
            <a:ext cx="3586607" cy="7935927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260F36D6-7F7A-4752-AB08-7DFB6CB4F010}"/>
              </a:ext>
            </a:extLst>
          </p:cNvPr>
          <p:cNvSpPr txBox="1"/>
          <p:nvPr/>
        </p:nvSpPr>
        <p:spPr>
          <a:xfrm>
            <a:off x="357981" y="8801100"/>
            <a:ext cx="79248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Phylogenetic tree for VIT family genes from </a:t>
            </a:r>
            <a:r>
              <a:rPr lang="en-I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abidopsis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IN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rachypodium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I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yza sativa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IN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Zea</a:t>
            </a:r>
            <a:r>
              <a:rPr lang="en-I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ays 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I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iticum </a:t>
            </a:r>
            <a:r>
              <a:rPr lang="en-IN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estivum</a:t>
            </a:r>
            <a:r>
              <a:rPr lang="en-I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quences were extracted using </a:t>
            </a:r>
            <a:r>
              <a:rPr lang="en-I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fam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D followed by alignment by Muscle and construction of NJ tree using MEGA software. </a:t>
            </a:r>
          </a:p>
        </p:txBody>
      </p:sp>
    </p:spTree>
    <p:extLst>
      <p:ext uri="{BB962C8B-B14F-4D97-AF65-F5344CB8AC3E}">
        <p14:creationId xmlns:p14="http://schemas.microsoft.com/office/powerpoint/2010/main" val="20927879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Picture 48">
            <a:extLst>
              <a:ext uri="{FF2B5EF4-FFF2-40B4-BE49-F238E27FC236}">
                <a16:creationId xmlns:a16="http://schemas.microsoft.com/office/drawing/2014/main" id="{A72412C9-39A3-4E01-BFB8-13EB2E5B405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6581" y="307918"/>
            <a:ext cx="7849610" cy="4530782"/>
          </a:xfrm>
          <a:prstGeom prst="rect">
            <a:avLst/>
          </a:prstGeom>
        </p:spPr>
      </p:pic>
      <p:pic>
        <p:nvPicPr>
          <p:cNvPr id="50" name="Picture 49">
            <a:extLst>
              <a:ext uri="{FF2B5EF4-FFF2-40B4-BE49-F238E27FC236}">
                <a16:creationId xmlns:a16="http://schemas.microsoft.com/office/drawing/2014/main" id="{55D67BA1-0A37-4F6A-8E61-8C70AEBB327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4273" y="4991100"/>
            <a:ext cx="7849610" cy="4115942"/>
          </a:xfrm>
          <a:prstGeom prst="rect">
            <a:avLst/>
          </a:prstGeom>
        </p:spPr>
      </p:pic>
      <p:sp>
        <p:nvSpPr>
          <p:cNvPr id="51" name="TextBox 50">
            <a:extLst>
              <a:ext uri="{FF2B5EF4-FFF2-40B4-BE49-F238E27FC236}">
                <a16:creationId xmlns:a16="http://schemas.microsoft.com/office/drawing/2014/main" id="{A8BC1527-EC9A-4B01-90DF-9ACEA9CE0BD9}"/>
              </a:ext>
            </a:extLst>
          </p:cNvPr>
          <p:cNvSpPr txBox="1"/>
          <p:nvPr/>
        </p:nvSpPr>
        <p:spPr>
          <a:xfrm>
            <a:off x="346684" y="9596762"/>
            <a:ext cx="79248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Transmembrane domains in wheat VIT family proteins. Figure shows potential TM domains in </a:t>
            </a:r>
            <a:r>
              <a:rPr lang="en-IN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VIT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IN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VTL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teins, based on the alignment with </a:t>
            </a:r>
            <a:r>
              <a:rPr lang="en-I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gVIT1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tein, using MUSCLE. </a:t>
            </a:r>
          </a:p>
        </p:txBody>
      </p:sp>
    </p:spTree>
    <p:extLst>
      <p:ext uri="{BB962C8B-B14F-4D97-AF65-F5344CB8AC3E}">
        <p14:creationId xmlns:p14="http://schemas.microsoft.com/office/powerpoint/2010/main" val="6598108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793C90B1-398E-40CF-B7E5-8C058C16EFE2}"/>
              </a:ext>
            </a:extLst>
          </p:cNvPr>
          <p:cNvSpPr/>
          <p:nvPr/>
        </p:nvSpPr>
        <p:spPr>
          <a:xfrm>
            <a:off x="586505" y="8267700"/>
            <a:ext cx="7467751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Heatmap depicting the expression of VIT family genes (VIT and VTL genes) in Control (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PKM_Control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Fe starved (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PKM_Fe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wheat roots. FPKM values were extracted using Cufflinks pipeline from SRA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jectID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RP189420. Increasing intensity of blue colour shows increase in expression as shown by the colour bar above.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453DA871-0B3F-43A1-9926-E9AB89D3287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8333" b="13258"/>
          <a:stretch/>
        </p:blipFill>
        <p:spPr>
          <a:xfrm>
            <a:off x="1934190" y="414858"/>
            <a:ext cx="4407747" cy="71198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9872309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92D7303C-3205-4A93-9833-31B6E586D72F}"/>
              </a:ext>
            </a:extLst>
          </p:cNvPr>
          <p:cNvSpPr/>
          <p:nvPr/>
        </p:nvSpPr>
        <p:spPr>
          <a:xfrm>
            <a:off x="319881" y="6896100"/>
            <a:ext cx="8001000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Heatmap depicting the expression of VIT family genes (VIT and VTL genes) in Grain Tissue Developmental Time-course (WE: Whole endosperm, TC: Transfer cells, AL: Aleurone layer, SE: Starchy Endosperm,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pa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days post anthesis). FPKM values were extracted using </a:t>
            </a:r>
            <a:r>
              <a:rPr lang="en-I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VIP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tabase. Increasing intensity of blue </a:t>
            </a:r>
            <a:r>
              <a:rPr lang="en-I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lor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hows increase in expression as shown by the </a:t>
            </a:r>
            <a:r>
              <a:rPr lang="en-I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lor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ar above.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935E5E8-B1D3-4E02-B689-4480B6AA035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2500" b="12706"/>
          <a:stretch/>
        </p:blipFill>
        <p:spPr>
          <a:xfrm>
            <a:off x="1577181" y="1028700"/>
            <a:ext cx="5946089" cy="53232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520197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044</TotalTime>
  <Words>214</Words>
  <Application>Microsoft Office PowerPoint</Application>
  <PresentationFormat>Custom</PresentationFormat>
  <Paragraphs>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ll</dc:creator>
  <cp:lastModifiedBy>AK Pandey</cp:lastModifiedBy>
  <cp:revision>77</cp:revision>
  <dcterms:created xsi:type="dcterms:W3CDTF">2006-08-16T00:00:00Z</dcterms:created>
  <dcterms:modified xsi:type="dcterms:W3CDTF">2019-11-28T14:07:16Z</dcterms:modified>
</cp:coreProperties>
</file>